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040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37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483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5596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80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95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523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96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165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8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90750" y="6210299"/>
            <a:ext cx="11341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/>
              <a:t>Figure 6:</a:t>
            </a:r>
            <a:r>
              <a:rPr lang="en-AU" sz="1000" dirty="0"/>
              <a:t> </a:t>
            </a:r>
            <a:r>
              <a:rPr lang="en-AU" sz="1000" b="1" dirty="0"/>
              <a:t>A.</a:t>
            </a:r>
            <a:r>
              <a:rPr lang="en-AU" sz="1000" dirty="0"/>
              <a:t> Comparison of amino acid sequence identities of (1-9) contigs from five shrimp species that matched with sarcoplasmic calcium-binding protein (SCP) allergen and (10-12) known shrimp SCP allergen. The sequence identities were calculated using multiple sequence alignment in </a:t>
            </a:r>
            <a:r>
              <a:rPr lang="en-AU" sz="1000" dirty="0" err="1"/>
              <a:t>Clustal</a:t>
            </a:r>
            <a:r>
              <a:rPr lang="en-AU" sz="1000" dirty="0"/>
              <a:t> Omega (EMBL-EBI). </a:t>
            </a:r>
            <a:br>
              <a:rPr lang="en-AU" sz="1000" dirty="0"/>
            </a:br>
            <a:r>
              <a:rPr lang="en-AU" sz="1000" b="1" dirty="0"/>
              <a:t>B.</a:t>
            </a:r>
            <a:r>
              <a:rPr lang="en-AU" sz="1000" dirty="0"/>
              <a:t> Molecular phylogenetic tree based on published amino acid sequences of Sarcoplasmic calcium-binding protein (SCP) from edible crustacean and mollusc species; and allergy causing mite and insect species. The branches consist of </a:t>
            </a:r>
            <a:r>
              <a:rPr lang="en-AU" sz="1000" dirty="0" err="1"/>
              <a:t>UniProt</a:t>
            </a:r>
            <a:r>
              <a:rPr lang="en-AU" sz="1000" dirty="0"/>
              <a:t> ID/</a:t>
            </a:r>
            <a:r>
              <a:rPr lang="en-AU" sz="1000" dirty="0" err="1"/>
              <a:t>Genbank</a:t>
            </a:r>
            <a:r>
              <a:rPr lang="en-AU" sz="1000" dirty="0"/>
              <a:t> Accession ID, species name, and followed by common name in brackets. The numbers next to the branches indicate the bootstrap test percentage of 10,000 replicate trees.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1727" y="118872"/>
            <a:ext cx="5591496" cy="6091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2766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11</cp:revision>
  <dcterms:created xsi:type="dcterms:W3CDTF">2020-11-09T03:01:03Z</dcterms:created>
  <dcterms:modified xsi:type="dcterms:W3CDTF">2020-11-18T10:00:58Z</dcterms:modified>
</cp:coreProperties>
</file>